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A339EA-E92D-45FD-BF9F-356E44B8DD05}" v="3" dt="2024-09-27T14:37:53.480"/>
    <p1510:client id="{CB3C8A86-4494-468A-87D1-58921BB1BD71}" v="1" dt="2024-09-27T15:12:32.8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28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ladimir Beljanski" userId="e029ce77-daeb-4c7b-a9c0-9fcd2530f22c" providerId="ADAL" clId="{6FA339EA-E92D-45FD-BF9F-356E44B8DD05}"/>
    <pc:docChg chg="custSel modSld">
      <pc:chgData name="Vladimir Beljanski" userId="e029ce77-daeb-4c7b-a9c0-9fcd2530f22c" providerId="ADAL" clId="{6FA339EA-E92D-45FD-BF9F-356E44B8DD05}" dt="2024-09-27T14:52:08.019" v="5" actId="478"/>
      <pc:docMkLst>
        <pc:docMk/>
      </pc:docMkLst>
      <pc:sldChg chg="addSp delSp modSp mod">
        <pc:chgData name="Vladimir Beljanski" userId="e029ce77-daeb-4c7b-a9c0-9fcd2530f22c" providerId="ADAL" clId="{6FA339EA-E92D-45FD-BF9F-356E44B8DD05}" dt="2024-09-27T14:52:08.019" v="5" actId="478"/>
        <pc:sldMkLst>
          <pc:docMk/>
          <pc:sldMk cId="3360220787" sldId="256"/>
        </pc:sldMkLst>
        <pc:spChg chg="add mod">
          <ac:chgData name="Vladimir Beljanski" userId="e029ce77-daeb-4c7b-a9c0-9fcd2530f22c" providerId="ADAL" clId="{6FA339EA-E92D-45FD-BF9F-356E44B8DD05}" dt="2024-09-27T14:37:47.582" v="1"/>
          <ac:spMkLst>
            <pc:docMk/>
            <pc:sldMk cId="3360220787" sldId="256"/>
            <ac:spMk id="10" creationId="{097201D0-62F0-99C9-345F-C8AE530ACD69}"/>
          </ac:spMkLst>
        </pc:spChg>
        <pc:spChg chg="add del mod">
          <ac:chgData name="Vladimir Beljanski" userId="e029ce77-daeb-4c7b-a9c0-9fcd2530f22c" providerId="ADAL" clId="{6FA339EA-E92D-45FD-BF9F-356E44B8DD05}" dt="2024-09-27T14:52:08.019" v="5" actId="478"/>
          <ac:spMkLst>
            <pc:docMk/>
            <pc:sldMk cId="3360220787" sldId="256"/>
            <ac:spMk id="11" creationId="{097201D0-62F0-99C9-345F-C8AE530ACD69}"/>
          </ac:spMkLst>
        </pc:spChg>
      </pc:sldChg>
    </pc:docChg>
  </pc:docChgLst>
  <pc:docChgLst>
    <pc:chgData name="Vladimir Beljanski" userId="e029ce77-daeb-4c7b-a9c0-9fcd2530f22c" providerId="ADAL" clId="{480FB3BD-D8AF-4023-9AB4-5E52D85B3EFE}"/>
    <pc:docChg chg="delSld">
      <pc:chgData name="Vladimir Beljanski" userId="e029ce77-daeb-4c7b-a9c0-9fcd2530f22c" providerId="ADAL" clId="{480FB3BD-D8AF-4023-9AB4-5E52D85B3EFE}" dt="2024-05-03T19:46:02.738" v="0" actId="47"/>
      <pc:docMkLst>
        <pc:docMk/>
      </pc:docMkLst>
      <pc:sldChg chg="del">
        <pc:chgData name="Vladimir Beljanski" userId="e029ce77-daeb-4c7b-a9c0-9fcd2530f22c" providerId="ADAL" clId="{480FB3BD-D8AF-4023-9AB4-5E52D85B3EFE}" dt="2024-05-03T19:46:02.738" v="0" actId="47"/>
        <pc:sldMkLst>
          <pc:docMk/>
          <pc:sldMk cId="2478155357" sldId="257"/>
        </pc:sldMkLst>
      </pc:sldChg>
    </pc:docChg>
  </pc:docChgLst>
  <pc:docChgLst>
    <pc:chgData name="Vladimir Beljanski" userId="e029ce77-daeb-4c7b-a9c0-9fcd2530f22c" providerId="ADAL" clId="{CB3C8A86-4494-468A-87D1-58921BB1BD71}"/>
    <pc:docChg chg="modSld">
      <pc:chgData name="Vladimir Beljanski" userId="e029ce77-daeb-4c7b-a9c0-9fcd2530f22c" providerId="ADAL" clId="{CB3C8A86-4494-468A-87D1-58921BB1BD71}" dt="2024-09-27T15:13:08.402" v="23" actId="1076"/>
      <pc:docMkLst>
        <pc:docMk/>
      </pc:docMkLst>
      <pc:sldChg chg="addSp modSp mod">
        <pc:chgData name="Vladimir Beljanski" userId="e029ce77-daeb-4c7b-a9c0-9fcd2530f22c" providerId="ADAL" clId="{CB3C8A86-4494-468A-87D1-58921BB1BD71}" dt="2024-09-27T15:13:08.402" v="23" actId="1076"/>
        <pc:sldMkLst>
          <pc:docMk/>
          <pc:sldMk cId="3360220787" sldId="256"/>
        </pc:sldMkLst>
        <pc:spChg chg="add mod">
          <ac:chgData name="Vladimir Beljanski" userId="e029ce77-daeb-4c7b-a9c0-9fcd2530f22c" providerId="ADAL" clId="{CB3C8A86-4494-468A-87D1-58921BB1BD71}" dt="2024-09-27T15:13:08.402" v="23" actId="1076"/>
          <ac:spMkLst>
            <pc:docMk/>
            <pc:sldMk cId="3360220787" sldId="256"/>
            <ac:spMk id="10" creationId="{1FC2A484-5851-6680-E3F3-CAE40CB275F3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b_19\Downloads\Compile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b_19\Downloads\Compiled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b_19\Downloads\Compiled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vb_19\Downloads\Compiled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https://liverootnova-my.sharepoint.com/personal/vbeljanski_nova_edu/Documents/Nova/Exosomes/RT-PCR%20Validation%20VB-RP/Compiled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solidFill>
                  <a:schemeClr val="tx1"/>
                </a:solidFill>
                <a:effectLst/>
              </a:rPr>
              <a:t>miR-24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:$A$5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</c:strCache>
            </c:strRef>
          </c:cat>
          <c:val>
            <c:numRef>
              <c:f>[Compiled.xlsx]Sheet1!$B$3:$B$5</c:f>
              <c:numCache>
                <c:formatCode>General</c:formatCode>
                <c:ptCount val="3"/>
                <c:pt idx="0">
                  <c:v>9.7872307829247074</c:v>
                </c:pt>
                <c:pt idx="1">
                  <c:v>8.014462573119749</c:v>
                </c:pt>
                <c:pt idx="2">
                  <c:v>8.7164776442952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4E-4BF5-8604-23D732996255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rgbClr val="D600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2-9F4E-4BF5-8604-23D732996255}"/>
              </c:ext>
            </c:extLst>
          </c:dPt>
          <c:dPt>
            <c:idx val="1"/>
            <c:invertIfNegative val="0"/>
            <c:bubble3D val="0"/>
            <c:spPr>
              <a:solidFill>
                <a:srgbClr val="D600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4-9F4E-4BF5-8604-23D732996255}"/>
              </c:ext>
            </c:extLst>
          </c:dPt>
          <c:dPt>
            <c:idx val="2"/>
            <c:invertIfNegative val="0"/>
            <c:bubble3D val="0"/>
            <c:spPr>
              <a:solidFill>
                <a:srgbClr val="D60000"/>
              </a:solidFill>
              <a:ln>
                <a:noFill/>
              </a:ln>
              <a:effectLst/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6-9F4E-4BF5-8604-23D732996255}"/>
              </c:ext>
            </c:extLst>
          </c:dPt>
          <c:cat>
            <c:strRef>
              <c:f>[Compiled.xlsx]Sheet1!$A$3:$A$5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</c:strCache>
            </c:strRef>
          </c:cat>
          <c:val>
            <c:numRef>
              <c:f>[Compiled.xlsx]Sheet1!$C$3:$C$5</c:f>
              <c:numCache>
                <c:formatCode>General</c:formatCode>
                <c:ptCount val="3"/>
                <c:pt idx="0">
                  <c:v>1.78</c:v>
                </c:pt>
                <c:pt idx="1">
                  <c:v>1.85</c:v>
                </c:pt>
                <c:pt idx="2">
                  <c:v>1.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F4E-4BF5-8604-23D7329962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1307</a:t>
            </a:r>
            <a:r>
              <a:rPr lang="en-US" sz="1400" b="1" i="0" u="none" strike="noStrike" baseline="0"/>
              <a:t>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0823466203505854"/>
          <c:y val="3.870341723746588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20703433084534359"/>
          <c:w val="0.96418705323987031"/>
          <c:h val="0.7013808891668220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,[Compiled.xlsx]Sheet1!$A$7</c:f>
              <c:strCache>
                <c:ptCount val="4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  <c:pt idx="3">
                  <c:v>TX+IFN</c:v>
                </c:pt>
              </c:strCache>
            </c:strRef>
          </c:cat>
          <c:val>
            <c:numRef>
              <c:f>[Compiled.xlsx]Sheet1!$Q$3,[Compiled.xlsx]Sheet1!$Q$4,[Compiled.xlsx]Sheet1!$Q$6,[Compiled.xlsx]Sheet1!$Q$7</c:f>
              <c:numCache>
                <c:formatCode>General</c:formatCode>
                <c:ptCount val="4"/>
                <c:pt idx="0">
                  <c:v>-0.20890093201513837</c:v>
                </c:pt>
                <c:pt idx="1">
                  <c:v>-0.29301487455935593</c:v>
                </c:pt>
                <c:pt idx="2">
                  <c:v>-0.33413623537902493</c:v>
                </c:pt>
                <c:pt idx="3">
                  <c:v>-0.49938143661644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88-4914-A0E6-1F4925DA7299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,[Compiled.xlsx]Sheet1!$A$7</c:f>
              <c:strCache>
                <c:ptCount val="4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  <c:pt idx="3">
                  <c:v>TX+IFN</c:v>
                </c:pt>
              </c:strCache>
            </c:strRef>
          </c:cat>
          <c:val>
            <c:numRef>
              <c:f>[Compiled.xlsx]Sheet1!$R$3,[Compiled.xlsx]Sheet1!$R$4,[Compiled.xlsx]Sheet1!$R$6,[Compiled.xlsx]Sheet1!$R$7</c:f>
              <c:numCache>
                <c:formatCode>General</c:formatCode>
                <c:ptCount val="4"/>
                <c:pt idx="0">
                  <c:v>-2.1800000000000002</c:v>
                </c:pt>
                <c:pt idx="1">
                  <c:v>-2.1</c:v>
                </c:pt>
                <c:pt idx="2">
                  <c:v>-1.72</c:v>
                </c:pt>
                <c:pt idx="3">
                  <c:v>-1.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88-4914-A0E6-1F4925DA72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high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10396b</a:t>
            </a:r>
            <a:r>
              <a:rPr lang="en-US" sz="1400" b="1" i="0" u="none" strike="noStrike" baseline="0"/>
              <a:t> 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918573019974472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261968467927177"/>
          <c:y val="0.22638603946407648"/>
          <c:w val="0.96418705323987031"/>
          <c:h val="0.693640205719328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4</c:f>
              <c:strCache>
                <c:ptCount val="1"/>
                <c:pt idx="0">
                  <c:v>TX</c:v>
                </c:pt>
              </c:strCache>
            </c:strRef>
          </c:cat>
          <c:val>
            <c:numRef>
              <c:f>[Compiled.xlsx]Sheet1!$T$4</c:f>
              <c:numCache>
                <c:formatCode>General</c:formatCode>
                <c:ptCount val="1"/>
                <c:pt idx="0">
                  <c:v>-0.914215388286689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43-42E6-8C4F-1ADA0E5F2D4D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4</c:f>
              <c:strCache>
                <c:ptCount val="1"/>
                <c:pt idx="0">
                  <c:v>TX</c:v>
                </c:pt>
              </c:strCache>
            </c:strRef>
          </c:cat>
          <c:val>
            <c:numRef>
              <c:f>[Compiled.xlsx]Sheet1!$U$4</c:f>
              <c:numCache>
                <c:formatCode>General</c:formatCode>
                <c:ptCount val="1"/>
                <c:pt idx="0">
                  <c:v>-22.81835400440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43-42E6-8C4F-1ADA0E5F2D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high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0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 dirty="0">
                <a:effectLst/>
              </a:rPr>
              <a:t>mir-</a:t>
            </a:r>
          </a:p>
          <a:p>
            <a:pPr>
              <a:defRPr b="1">
                <a:solidFill>
                  <a:schemeClr val="tx1"/>
                </a:solidFill>
              </a:defRPr>
            </a:pPr>
            <a:r>
              <a:rPr lang="en-US" sz="1400" b="1" i="0" u="none" strike="noStrike" baseline="0" dirty="0">
                <a:effectLst/>
              </a:rPr>
              <a:t>let-7e</a:t>
            </a:r>
            <a:r>
              <a:rPr lang="en-US" sz="1400" b="1" i="0" u="none" strike="noStrike" baseline="0" dirty="0"/>
              <a:t>  </a:t>
            </a:r>
            <a:r>
              <a:rPr lang="en-US" sz="1400" b="1" i="0" u="none" strike="noStrike" baseline="0" dirty="0">
                <a:solidFill>
                  <a:schemeClr val="tx1"/>
                </a:solidFill>
              </a:rPr>
              <a:t> </a:t>
            </a:r>
            <a:endParaRPr lang="en-US" b="1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3022076754582886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261968467927177"/>
          <c:y val="0.22638603946407648"/>
          <c:w val="0.96418705323987031"/>
          <c:h val="0.693640205719328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5</c:f>
              <c:strCache>
                <c:ptCount val="1"/>
                <c:pt idx="0">
                  <c:v>IFN</c:v>
                </c:pt>
              </c:strCache>
            </c:strRef>
          </c:cat>
          <c:val>
            <c:numRef>
              <c:f>[Compiled.xlsx]Sheet1!$W$5</c:f>
              <c:numCache>
                <c:formatCode>General</c:formatCode>
                <c:ptCount val="1"/>
                <c:pt idx="0">
                  <c:v>-4.35688386993732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BA-4210-BBAF-CDC4E46476D8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5</c:f>
              <c:strCache>
                <c:ptCount val="1"/>
                <c:pt idx="0">
                  <c:v>IFN</c:v>
                </c:pt>
              </c:strCache>
            </c:strRef>
          </c:cat>
          <c:val>
            <c:numRef>
              <c:f>[Compiled.xlsx]Sheet1!$X$5</c:f>
              <c:numCache>
                <c:formatCode>General</c:formatCode>
                <c:ptCount val="1"/>
                <c:pt idx="0">
                  <c:v>-1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BA-4210-BBAF-CDC4E46476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high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0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 dirty="0">
                <a:effectLst/>
              </a:rPr>
              <a:t>mir-99b</a:t>
            </a:r>
            <a:r>
              <a:rPr lang="en-US" sz="1400" b="0" i="0" u="none" strike="noStrike" baseline="0" dirty="0"/>
              <a:t> </a:t>
            </a:r>
            <a:r>
              <a:rPr lang="en-US" sz="1400" b="0" i="0" u="none" strike="noStrike" baseline="0" dirty="0">
                <a:solidFill>
                  <a:schemeClr val="tx1"/>
                </a:solidFill>
              </a:rPr>
              <a:t> </a:t>
            </a:r>
            <a:endParaRPr lang="en-US" b="0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[Compiled.xlsx]Sheet1!$E$3,[Compiled.xlsx]Sheet1!$E$4,[Compiled.xlsx]Sheet1!$E$6</c:f>
              <c:numCache>
                <c:formatCode>General</c:formatCode>
                <c:ptCount val="3"/>
                <c:pt idx="0">
                  <c:v>0.67870706409631087</c:v>
                </c:pt>
                <c:pt idx="1">
                  <c:v>0.38002996243264953</c:v>
                </c:pt>
                <c:pt idx="2">
                  <c:v>3.2957979645439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76-4D95-AF14-B99524DEE010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[Compiled.xlsx]Sheet1!$F$3,[Compiled.xlsx]Sheet1!$F$4,[Compiled.xlsx]Sheet1!$F$6</c:f>
              <c:numCache>
                <c:formatCode>General</c:formatCode>
                <c:ptCount val="3"/>
                <c:pt idx="0">
                  <c:v>1.6787070640963109</c:v>
                </c:pt>
                <c:pt idx="1">
                  <c:v>1.3800299624326495</c:v>
                </c:pt>
                <c:pt idx="2">
                  <c:v>4.2957979645439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76-4D95-AF14-B99524DEE0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146b</a:t>
            </a:r>
            <a:r>
              <a:rPr lang="en-US" sz="1400" b="0" i="0" u="none" strike="noStrike" baseline="0"/>
              <a:t>  </a:t>
            </a:r>
            <a:r>
              <a:rPr lang="en-US" sz="1400" b="0" i="0" u="none" strike="noStrike" baseline="0">
                <a:solidFill>
                  <a:schemeClr val="tx1"/>
                </a:solidFill>
              </a:rPr>
              <a:t> </a:t>
            </a:r>
            <a:endParaRPr lang="en-US" b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5,[Compiled.xlsx]Sheet1!$A$6</c:f>
              <c:strCache>
                <c:ptCount val="2"/>
                <c:pt idx="0">
                  <c:v>IFN</c:v>
                </c:pt>
                <c:pt idx="1">
                  <c:v>CQ+IFN</c:v>
                </c:pt>
              </c:strCache>
            </c:strRef>
          </c:cat>
          <c:val>
            <c:numRef>
              <c:f>[Compiled.xlsx]Sheet1!$H$5,[Compiled.xlsx]Sheet1!$H$6</c:f>
              <c:numCache>
                <c:formatCode>General</c:formatCode>
                <c:ptCount val="2"/>
                <c:pt idx="0">
                  <c:v>0.59101724513933429</c:v>
                </c:pt>
                <c:pt idx="1">
                  <c:v>11.0419831533977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AD-48A1-BAE5-756B8F3F383D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5,[Compiled.xlsx]Sheet1!$A$6</c:f>
              <c:strCache>
                <c:ptCount val="2"/>
                <c:pt idx="0">
                  <c:v>IFN</c:v>
                </c:pt>
                <c:pt idx="1">
                  <c:v>CQ+IFN</c:v>
                </c:pt>
              </c:strCache>
            </c:strRef>
          </c:cat>
          <c:val>
            <c:numRef>
              <c:f>[Compiled.xlsx]Sheet1!$I$5,[Compiled.xlsx]Sheet1!$I$6</c:f>
              <c:numCache>
                <c:formatCode>General</c:formatCode>
                <c:ptCount val="2"/>
                <c:pt idx="0">
                  <c:v>3.29</c:v>
                </c:pt>
                <c:pt idx="1">
                  <c:v>6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AD-48A1-BAE5-756B8F3F3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191</a:t>
            </a:r>
            <a:r>
              <a:rPr lang="en-US" sz="1400" b="1" i="0" u="none" strike="noStrike" baseline="0"/>
              <a:t>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[Compiled.xlsx]Sheet1!$K$3,[Compiled.xlsx]Sheet1!$K$4,[Compiled.xlsx]Sheet1!$K$6</c:f>
              <c:numCache>
                <c:formatCode>General</c:formatCode>
                <c:ptCount val="3"/>
                <c:pt idx="0">
                  <c:v>5.0976565434768171</c:v>
                </c:pt>
                <c:pt idx="1">
                  <c:v>3.583975441853803</c:v>
                </c:pt>
                <c:pt idx="2">
                  <c:v>13.0785768065235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91-4590-B162-822A78000E3E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,[Compiled.xlsx]Sheet1!$A$4,[Compiled.xlsx]Sheet1!$A$6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[Compiled.xlsx]Sheet1!$L$3,[Compiled.xlsx]Sheet1!$L$4,[Compiled.xlsx]Sheet1!$L$6</c:f>
              <c:numCache>
                <c:formatCode>General</c:formatCode>
                <c:ptCount val="3"/>
                <c:pt idx="0">
                  <c:v>3.81</c:v>
                </c:pt>
                <c:pt idx="1">
                  <c:v>5.08</c:v>
                </c:pt>
                <c:pt idx="2">
                  <c:v>4.11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91-4590-B162-822A78000E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23b</a:t>
            </a:r>
            <a:r>
              <a:rPr lang="en-US" sz="1400" b="1" i="0" u="none" strike="noStrike" baseline="0"/>
              <a:t> 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B$6</c:f>
              <c:strCache>
                <c:ptCount val="1"/>
                <c:pt idx="0">
                  <c:v>CQ+IFN</c:v>
                </c:pt>
              </c:strCache>
            </c:strRef>
          </c:cat>
          <c:val>
            <c:numRef>
              <c:f>Sheet1!$AC$6</c:f>
              <c:numCache>
                <c:formatCode>General</c:formatCode>
                <c:ptCount val="1"/>
                <c:pt idx="0">
                  <c:v>1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F6-4D5A-B290-6368E32A2E04}"/>
            </c:ext>
          </c:extLst>
        </c:ser>
        <c:ser>
          <c:idx val="1"/>
          <c:order val="1"/>
          <c:tx>
            <c:strRef>
              <c:f>Sheet1!$AD$6</c:f>
              <c:strCache>
                <c:ptCount val="1"/>
                <c:pt idx="0">
                  <c:v>5.51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B$6</c:f>
              <c:strCache>
                <c:ptCount val="1"/>
                <c:pt idx="0">
                  <c:v>CQ+IFN</c:v>
                </c:pt>
              </c:strCache>
            </c:strRef>
          </c:cat>
          <c:val>
            <c:numRef>
              <c:f>Sheet1!$AD$6</c:f>
              <c:numCache>
                <c:formatCode>General</c:formatCode>
                <c:ptCount val="1"/>
                <c:pt idx="0">
                  <c:v>5.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F6-4D5A-B290-6368E32A2E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4516</a:t>
            </a:r>
            <a:r>
              <a:rPr lang="en-US" sz="1400" b="1" i="0" u="none" strike="noStrike" baseline="0"/>
              <a:t> 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E$6:$AE$7</c:f>
              <c:strCache>
                <c:ptCount val="2"/>
                <c:pt idx="0">
                  <c:v>CQ+IFN</c:v>
                </c:pt>
                <c:pt idx="1">
                  <c:v>TX+IFN</c:v>
                </c:pt>
              </c:strCache>
            </c:strRef>
          </c:cat>
          <c:val>
            <c:numRef>
              <c:f>(Sheet1!$AF$6,Sheet1!$AF$7)</c:f>
              <c:numCache>
                <c:formatCode>General</c:formatCode>
                <c:ptCount val="2"/>
                <c:pt idx="0">
                  <c:v>10.96</c:v>
                </c:pt>
                <c:pt idx="1">
                  <c:v>6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D5-4D3E-A23F-7C6CACDB3245}"/>
            </c:ext>
          </c:extLst>
        </c:ser>
        <c:ser>
          <c:idx val="1"/>
          <c:order val="1"/>
          <c:spPr>
            <a:solidFill>
              <a:srgbClr val="C0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E$6:$AE$7</c:f>
              <c:strCache>
                <c:ptCount val="2"/>
                <c:pt idx="0">
                  <c:v>CQ+IFN</c:v>
                </c:pt>
                <c:pt idx="1">
                  <c:v>TX+IFN</c:v>
                </c:pt>
              </c:strCache>
            </c:strRef>
          </c:cat>
          <c:val>
            <c:numRef>
              <c:f>(Sheet1!$AG$6,Sheet1!$AG$7)</c:f>
              <c:numCache>
                <c:formatCode>General</c:formatCode>
                <c:ptCount val="2"/>
                <c:pt idx="0">
                  <c:v>4.1100000000000003</c:v>
                </c:pt>
                <c:pt idx="1">
                  <c:v>4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D5-4D3E-A23F-7C6CACDB32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100</a:t>
            </a:r>
            <a:r>
              <a:rPr lang="en-US" sz="1400" b="1" i="0" u="none" strike="noStrike" baseline="0"/>
              <a:t>  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(Sheet1!$AH$3:$AH$4,Sheet1!$AH$6)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(Sheet1!$AI$3,Sheet1!$AI$4,Sheet1!$AI$6)</c:f>
              <c:numCache>
                <c:formatCode>General</c:formatCode>
                <c:ptCount val="3"/>
                <c:pt idx="0">
                  <c:v>3.87</c:v>
                </c:pt>
                <c:pt idx="1">
                  <c:v>2.87</c:v>
                </c:pt>
                <c:pt idx="2">
                  <c:v>4.23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B0-4749-836D-1AD4C854E913}"/>
            </c:ext>
          </c:extLst>
        </c:ser>
        <c:ser>
          <c:idx val="1"/>
          <c:order val="1"/>
          <c:spPr>
            <a:solidFill>
              <a:srgbClr val="C0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(Sheet1!$AH$3:$AH$4,Sheet1!$AH$6)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CQ+IFN</c:v>
                </c:pt>
              </c:strCache>
            </c:strRef>
          </c:cat>
          <c:val>
            <c:numRef>
              <c:f>(Sheet1!$AJ$3,Sheet1!$AJ$4,Sheet1!$AJ$6)</c:f>
              <c:numCache>
                <c:formatCode>General</c:formatCode>
                <c:ptCount val="3"/>
                <c:pt idx="0">
                  <c:v>3.74</c:v>
                </c:pt>
                <c:pt idx="1">
                  <c:v>4.3099999999999996</c:v>
                </c:pt>
                <c:pt idx="2">
                  <c:v>4.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B0-4749-836D-1AD4C854E9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 dirty="0">
                <a:effectLst/>
              </a:rPr>
              <a:t>mir-193b</a:t>
            </a:r>
            <a:r>
              <a:rPr lang="en-US" sz="1400" b="1" i="0" u="none" strike="noStrike" baseline="0" dirty="0"/>
              <a:t>   </a:t>
            </a:r>
            <a:r>
              <a:rPr lang="en-US" sz="1400" b="1" i="0" u="none" strike="noStrike" baseline="0" dirty="0">
                <a:solidFill>
                  <a:schemeClr val="tx1"/>
                </a:solidFill>
              </a:rPr>
              <a:t> </a:t>
            </a:r>
            <a:endParaRPr lang="en-US" b="1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6139403223061281E-2"/>
          <c:y val="0.13349783809415841"/>
          <c:w val="0.96418705323987031"/>
          <c:h val="0.77491738191800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K$3:$AK$6</c:f>
              <c:strCache>
                <c:ptCount val="4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  <c:pt idx="3">
                  <c:v>CQ+IFN</c:v>
                </c:pt>
              </c:strCache>
            </c:strRef>
          </c:cat>
          <c:val>
            <c:numRef>
              <c:f>Sheet1!$AL$3:$AL$6</c:f>
              <c:numCache>
                <c:formatCode>General</c:formatCode>
                <c:ptCount val="4"/>
                <c:pt idx="0">
                  <c:v>3.37</c:v>
                </c:pt>
                <c:pt idx="1">
                  <c:v>3.37</c:v>
                </c:pt>
                <c:pt idx="2">
                  <c:v>2.79</c:v>
                </c:pt>
                <c:pt idx="3">
                  <c:v>5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18-4F83-A8F9-388A5AB08529}"/>
            </c:ext>
          </c:extLst>
        </c:ser>
        <c:ser>
          <c:idx val="1"/>
          <c:order val="1"/>
          <c:spPr>
            <a:solidFill>
              <a:srgbClr val="C0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Sheet1!$AK$3:$AK$6</c:f>
              <c:strCache>
                <c:ptCount val="4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  <c:pt idx="3">
                  <c:v>CQ+IFN</c:v>
                </c:pt>
              </c:strCache>
            </c:strRef>
          </c:cat>
          <c:val>
            <c:numRef>
              <c:f>Sheet1!$AM$3:$AM$6</c:f>
              <c:numCache>
                <c:formatCode>General</c:formatCode>
                <c:ptCount val="4"/>
                <c:pt idx="0">
                  <c:v>1.88</c:v>
                </c:pt>
                <c:pt idx="1">
                  <c:v>2.88</c:v>
                </c:pt>
                <c:pt idx="2">
                  <c:v>1.97</c:v>
                </c:pt>
                <c:pt idx="3">
                  <c:v>1.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18-4F83-A8F9-388A5AB085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u="none" strike="noStrike" baseline="0">
                <a:effectLst/>
              </a:rPr>
              <a:t>mir-625</a:t>
            </a:r>
            <a:r>
              <a:rPr lang="en-US" sz="1400" b="1" i="0" u="none" strike="noStrike" baseline="0"/>
              <a:t> </a:t>
            </a:r>
            <a:r>
              <a:rPr lang="en-US" sz="1400" b="1" i="0" u="none" strike="noStrike" baseline="0">
                <a:solidFill>
                  <a:schemeClr val="tx1"/>
                </a:solidFill>
              </a:rPr>
              <a:t> </a:t>
            </a:r>
            <a:endParaRPr lang="en-US" b="1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7798115555341651"/>
          <c:y val="2.709239206622611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261968467927177"/>
          <c:y val="0.22638603946407648"/>
          <c:w val="0.96418705323987031"/>
          <c:h val="0.693640205719328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2E1FF1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:$A$5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</c:strCache>
            </c:strRef>
          </c:cat>
          <c:val>
            <c:numRef>
              <c:f>[Compiled.xlsx]Sheet1!$N$5</c:f>
              <c:numCache>
                <c:formatCode>General</c:formatCode>
                <c:ptCount val="1"/>
                <c:pt idx="0">
                  <c:v>-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0E-4F28-B65A-DF5BF323DE86}"/>
            </c:ext>
          </c:extLst>
        </c:ser>
        <c:ser>
          <c:idx val="1"/>
          <c:order val="1"/>
          <c:spPr>
            <a:solidFill>
              <a:srgbClr val="D60000"/>
            </a:solidFill>
            <a:ln>
              <a:noFill/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strRef>
              <c:f>[Compiled.xlsx]Sheet1!$A$3:$A$5</c:f>
              <c:strCache>
                <c:ptCount val="3"/>
                <c:pt idx="0">
                  <c:v>CQ</c:v>
                </c:pt>
                <c:pt idx="1">
                  <c:v>TX</c:v>
                </c:pt>
                <c:pt idx="2">
                  <c:v>IFN</c:v>
                </c:pt>
              </c:strCache>
            </c:strRef>
          </c:cat>
          <c:val>
            <c:numRef>
              <c:f>[Compiled.xlsx]Sheet1!$O$5</c:f>
              <c:numCache>
                <c:formatCode>General</c:formatCode>
                <c:ptCount val="1"/>
                <c:pt idx="0">
                  <c:v>-1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30E-4F28-B65A-DF5BF323DE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8144975"/>
        <c:axId val="698149775"/>
      </c:barChart>
      <c:catAx>
        <c:axId val="698144975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high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9775"/>
        <c:crosses val="autoZero"/>
        <c:auto val="1"/>
        <c:lblAlgn val="ctr"/>
        <c:lblOffset val="100"/>
        <c:noMultiLvlLbl val="0"/>
      </c:catAx>
      <c:valAx>
        <c:axId val="698149775"/>
        <c:scaling>
          <c:orientation val="minMax"/>
          <c:max val="0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8144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D58958-7B3C-E0FC-A2CB-D03BCC7B34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5D9AFC-8580-354C-A360-5C25C77060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908192-155A-DE37-47FC-3A64BAC08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F272-8282-C1F8-7A1B-B25DFA97B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6A299B-E01F-5489-2272-225D2B494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C61C4-8086-BD18-36CD-FF4138BB1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082C56-0F2F-AAA6-2240-78D198F10D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CC6B8-2B29-579C-8564-353D00855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E2BE92-99EB-2B53-FAE2-D0324BC1F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ACCFBE-1E2E-F418-2C59-0B61CD440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161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A7A4E7-BE2C-4716-B33F-C72D2926B7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201E8C-F6A8-8E2D-4C24-C8A4B26B00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18A30F-67B2-F009-095C-288839B38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10939-AC7F-FA4D-EC51-3C99F85E6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48A326-66F2-CAD1-D5EF-05687C623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076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C6DEC4-DE0E-111A-695D-98FEEC8A07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45B0B2-6D22-7984-0793-C5CF1135B9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0F07F-C092-5174-13C9-40B40532F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1E5B4-AD85-A637-B753-2B04B70D7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9FE2F4-89AA-ACAA-98B0-2F0E7B731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321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D68AA3-FFC5-8D31-919B-886517B71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35CAF4-C24E-81B5-9B7E-40DEA0F0A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02650B-9F5F-5FB9-3C27-3A3F52D2B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31E4DC-5137-89B0-C5BC-E8D8F1CD6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49887-E2B1-9558-9AE0-993959CC3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429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AD590F-AA2E-BC70-D722-B5D3B0C6B7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5B46C3-E8E0-7C54-929A-EEA2AA9CB5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8B1ADE-8F3C-B8F5-144F-821C38ABAF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6DCB02-F52E-835B-F992-E5DC979CF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2B28D7-747C-E499-4B6F-908B18BA3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6BA02D-E73C-A0F6-26C8-10D6B36A2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415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3A6C2-4260-FACD-D087-77311B460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4DA3E1-C067-18E7-CC98-109908EDF3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F5C0D1-3934-6425-CF54-1E8957B854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D97DAA-BA98-BA81-45D8-868D74E685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A6C611-CBA2-FB5D-4858-BBC90FB337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EBDBF2D-DF85-6E08-3E3D-6BB44C3FF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44DD5B-124A-3C16-EAE7-02D272593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EDEBF8-9365-0FD1-B076-5EB9E516C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819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C1460B-0047-668B-DC2B-F610EC77FD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503D56E-D7CD-67E2-8791-7D775A6E4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DD3AD3-9B23-0C94-326D-17393E96E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C564EA-4479-3FB6-25DA-BC5744C9D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613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381156-E093-B59C-81D5-15579B918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1EF864-D41A-07AA-6E35-95EF23FF6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9D4D92-DD6B-E40B-53D6-E69613D0F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23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8A5256-1230-8CAF-18D8-FF09F8013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4F67C1-0306-05DF-7460-DB43062C23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42DA61-1EFC-EF8A-366B-247EFDA568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DE4EB8-9B18-7561-639F-326153143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8C66FB-8904-69E3-008A-E2A1C26CD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9DEB25-61F0-A33B-F277-2039FD73F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512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A57CD-3A78-42E8-C129-29F4D2B94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DD619F-237E-9102-5A38-DB6034E199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A2D0EA-F0D4-B05E-2D8B-F45DCC9CD7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5A27D0-8315-0A60-6E92-958E6AC19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EC2DFC-8983-8180-89B4-C0BCAB8CD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30BAB9-59FE-86A2-8B0F-8C49A7F5B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8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B9C1BB-A89E-5549-16DF-3CD0E71C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B47CA5-B443-2448-C716-271DFC209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DAB594-3220-EF65-A38A-137B04D9EC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6F9551-1D33-425D-B2A9-409A7A3EDB5D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9D55F-C538-34F5-506F-F7EB2083EE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12F1C8-E152-E47F-8621-1070365750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DBBB67-7AE6-4187-BA38-5DA30E1809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132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63FFF92-6121-7CDC-22F4-32244E7235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6700382"/>
              </p:ext>
            </p:extLst>
          </p:nvPr>
        </p:nvGraphicFramePr>
        <p:xfrm>
          <a:off x="556324" y="114586"/>
          <a:ext cx="1887630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BD60C99-DB0C-470A-A76C-7CC175E724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2366864"/>
              </p:ext>
            </p:extLst>
          </p:nvPr>
        </p:nvGraphicFramePr>
        <p:xfrm>
          <a:off x="2657703" y="114586"/>
          <a:ext cx="1942811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3ED45C5-F0C7-4A54-871B-CAEA0E849B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8834482"/>
              </p:ext>
            </p:extLst>
          </p:nvPr>
        </p:nvGraphicFramePr>
        <p:xfrm>
          <a:off x="4759083" y="114586"/>
          <a:ext cx="1538568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DD471379-EC95-411C-A5E8-37DFFDD552F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054758"/>
              </p:ext>
            </p:extLst>
          </p:nvPr>
        </p:nvGraphicFramePr>
        <p:xfrm>
          <a:off x="6456220" y="114586"/>
          <a:ext cx="2311773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BEB18E01-0DA0-4F22-8BE4-3AD4E7F6E9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2387169"/>
              </p:ext>
            </p:extLst>
          </p:nvPr>
        </p:nvGraphicFramePr>
        <p:xfrm>
          <a:off x="10809754" y="88104"/>
          <a:ext cx="905716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EBCFCDC-1C4E-49C2-AE56-335119C22B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2191394"/>
              </p:ext>
            </p:extLst>
          </p:nvPr>
        </p:nvGraphicFramePr>
        <p:xfrm>
          <a:off x="8926562" y="106576"/>
          <a:ext cx="1711133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F13E6754-D825-461A-806C-1FC32E1F04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7272666"/>
              </p:ext>
            </p:extLst>
          </p:nvPr>
        </p:nvGraphicFramePr>
        <p:xfrm>
          <a:off x="454208" y="3462051"/>
          <a:ext cx="2269478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FDA7C2E3-769D-4351-B44F-6B71D8BB4D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0264955"/>
              </p:ext>
            </p:extLst>
          </p:nvPr>
        </p:nvGraphicFramePr>
        <p:xfrm>
          <a:off x="2886457" y="3452814"/>
          <a:ext cx="2908786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3199FF39-51D3-A8A6-2DB6-527DA94852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0396981"/>
              </p:ext>
            </p:extLst>
          </p:nvPr>
        </p:nvGraphicFramePr>
        <p:xfrm>
          <a:off x="5972804" y="3462051"/>
          <a:ext cx="896589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A25CEBA6-D4D0-B4B2-1D20-2B73B3EF9E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5941979"/>
              </p:ext>
            </p:extLst>
          </p:nvPr>
        </p:nvGraphicFramePr>
        <p:xfrm>
          <a:off x="7009367" y="3452814"/>
          <a:ext cx="2911012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CFF79C08-C97D-1FD7-BE9E-37250B3FBF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2432540"/>
              </p:ext>
            </p:extLst>
          </p:nvPr>
        </p:nvGraphicFramePr>
        <p:xfrm>
          <a:off x="10060353" y="3433765"/>
          <a:ext cx="896589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932BFBEE-66F9-8693-978D-F3652778BE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5871762"/>
              </p:ext>
            </p:extLst>
          </p:nvPr>
        </p:nvGraphicFramePr>
        <p:xfrm>
          <a:off x="11134581" y="3429000"/>
          <a:ext cx="991133" cy="3281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DEE67BC-14FD-EA1A-C4AD-726DB079D0AF}"/>
              </a:ext>
            </a:extLst>
          </p:cNvPr>
          <p:cNvSpPr txBox="1"/>
          <p:nvPr/>
        </p:nvSpPr>
        <p:spPr>
          <a:xfrm rot="16200000">
            <a:off x="-454864" y="1570601"/>
            <a:ext cx="1396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ld chang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2647EC9-BB00-00C1-2912-EEA3AD9AE483}"/>
              </a:ext>
            </a:extLst>
          </p:cNvPr>
          <p:cNvSpPr txBox="1"/>
          <p:nvPr/>
        </p:nvSpPr>
        <p:spPr>
          <a:xfrm rot="16200000">
            <a:off x="-473399" y="4934746"/>
            <a:ext cx="1396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old chang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C2A484-5851-6680-E3F3-CAE40CB275F3}"/>
              </a:ext>
            </a:extLst>
          </p:cNvPr>
          <p:cNvSpPr txBox="1"/>
          <p:nvPr/>
        </p:nvSpPr>
        <p:spPr>
          <a:xfrm>
            <a:off x="8464873" y="6154763"/>
            <a:ext cx="118756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 Figure S3</a:t>
            </a:r>
          </a:p>
        </p:txBody>
      </p:sp>
    </p:spTree>
    <p:extLst>
      <p:ext uri="{BB962C8B-B14F-4D97-AF65-F5344CB8AC3E}">
        <p14:creationId xmlns:p14="http://schemas.microsoft.com/office/powerpoint/2010/main" val="336022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2c2b2d31-2e3e-4df1-b571-fb37c042ff1b}" enabled="0" method="" siteId="{2c2b2d31-2e3e-4df1-b571-fb37c042ff1b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20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ladimir Beljanski</dc:creator>
  <cp:lastModifiedBy>Vladimir Beljanski</cp:lastModifiedBy>
  <cp:revision>3</cp:revision>
  <cp:lastPrinted>2024-04-12T18:06:27Z</cp:lastPrinted>
  <dcterms:created xsi:type="dcterms:W3CDTF">2024-03-12T19:19:54Z</dcterms:created>
  <dcterms:modified xsi:type="dcterms:W3CDTF">2024-09-27T15:13:10Z</dcterms:modified>
</cp:coreProperties>
</file>